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81219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6359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45971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28347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61072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8787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7992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7198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564037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55609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54814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54019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53225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52430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51636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50841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50046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49252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48457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47663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46868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94369" y="46073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94369" y="45279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94369" y="44484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94369" y="43690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594369" y="42895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594369" y="42100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594369" y="413062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594369" y="40511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594369" y="39717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594369" y="389224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594369" y="381278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594369" y="37333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94369" y="36538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94369" y="35743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94369" y="34949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94369" y="34154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94369" y="333601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94369" y="32565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94369" y="31770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94369" y="30976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594369" y="30181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594369" y="293871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594369" y="28592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594369" y="27797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594369" y="27003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594369" y="26208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594369" y="25414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594369" y="246195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594369" y="238249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594369" y="23030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594369" y="222357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594369" y="21441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594369" y="20646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594369" y="19851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594369" y="19057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594369" y="18262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594369" y="17468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594369" y="166734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594369" y="15878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594369" y="15084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594369" y="14289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594369" y="13495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594369" y="12700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594369" y="119058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594369" y="11111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594369" y="10316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3224072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404783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487159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569535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487159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5269730" y="48457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3923111" y="4845767"/>
              <a:ext cx="1346619" cy="0"/>
            </a:xfrm>
            <a:custGeom>
              <a:avLst/>
              <a:pathLst>
                <a:path w="1346619" h="0">
                  <a:moveTo>
                    <a:pt x="13466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3923111" y="48457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5711732" y="28592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4395474" y="2859255"/>
              <a:ext cx="1316258" cy="0"/>
            </a:xfrm>
            <a:custGeom>
              <a:avLst/>
              <a:pathLst>
                <a:path w="1316258" h="0">
                  <a:moveTo>
                    <a:pt x="13162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4395474" y="28592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5510621" y="33360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4442717" y="3336018"/>
              <a:ext cx="1067904" cy="0"/>
            </a:xfrm>
            <a:custGeom>
              <a:avLst/>
              <a:pathLst>
                <a:path w="1067904" h="0">
                  <a:moveTo>
                    <a:pt x="10679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4442717" y="33360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5410108" y="5560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764225" y="5560911"/>
              <a:ext cx="2645882" cy="0"/>
            </a:xfrm>
            <a:custGeom>
              <a:avLst/>
              <a:pathLst>
                <a:path w="2645882" h="0">
                  <a:moveTo>
                    <a:pt x="26458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764225" y="55609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4840194" y="5243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3954488" y="5243069"/>
              <a:ext cx="885706" cy="0"/>
            </a:xfrm>
            <a:custGeom>
              <a:avLst/>
              <a:pathLst>
                <a:path w="885706" h="0">
                  <a:moveTo>
                    <a:pt x="8857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3954488" y="52430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5490811" y="34949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4411482" y="3494939"/>
              <a:ext cx="1079328" cy="0"/>
            </a:xfrm>
            <a:custGeom>
              <a:avLst/>
              <a:pathLst>
                <a:path w="1079328" h="0">
                  <a:moveTo>
                    <a:pt x="10793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4411482" y="34949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5344157" y="2541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4853191" y="2541413"/>
              <a:ext cx="490966" cy="0"/>
            </a:xfrm>
            <a:custGeom>
              <a:avLst/>
              <a:pathLst>
                <a:path w="490966" h="0">
                  <a:moveTo>
                    <a:pt x="49096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4853191" y="25414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5327898" y="4607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4021395" y="4607385"/>
              <a:ext cx="1306502" cy="0"/>
            </a:xfrm>
            <a:custGeom>
              <a:avLst/>
              <a:pathLst>
                <a:path w="1306502" h="0">
                  <a:moveTo>
                    <a:pt x="13065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4021395" y="4607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5324004" y="4289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4201643" y="4289544"/>
              <a:ext cx="1122360" cy="0"/>
            </a:xfrm>
            <a:custGeom>
              <a:avLst/>
              <a:pathLst>
                <a:path w="1122360" h="0">
                  <a:moveTo>
                    <a:pt x="112236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4201643" y="42895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6088759" y="10316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5012379" y="1031665"/>
              <a:ext cx="1076379" cy="0"/>
            </a:xfrm>
            <a:custGeom>
              <a:avLst/>
              <a:pathLst>
                <a:path w="1076379" h="0">
                  <a:moveTo>
                    <a:pt x="10763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5012379" y="10316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5815980" y="1587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4806607" y="1587888"/>
              <a:ext cx="1009373" cy="0"/>
            </a:xfrm>
            <a:custGeom>
              <a:avLst/>
              <a:pathLst>
                <a:path w="1009373" h="0">
                  <a:moveTo>
                    <a:pt x="10093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4806607" y="15878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6113980" y="1349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4715429" y="1349507"/>
              <a:ext cx="1398551" cy="0"/>
            </a:xfrm>
            <a:custGeom>
              <a:avLst/>
              <a:pathLst>
                <a:path w="1398551" h="0">
                  <a:moveTo>
                    <a:pt x="13985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4715429" y="13495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5143563" y="3971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4459405" y="3971702"/>
              <a:ext cx="684157" cy="0"/>
            </a:xfrm>
            <a:custGeom>
              <a:avLst/>
              <a:pathLst>
                <a:path w="684157" h="0">
                  <a:moveTo>
                    <a:pt x="68415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4459405" y="3971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5368098" y="4527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4013434" y="4527925"/>
              <a:ext cx="1354663" cy="0"/>
            </a:xfrm>
            <a:custGeom>
              <a:avLst/>
              <a:pathLst>
                <a:path w="1354663" h="0">
                  <a:moveTo>
                    <a:pt x="135466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4013434" y="45279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5215794" y="34154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4712681" y="3415479"/>
              <a:ext cx="503112" cy="0"/>
            </a:xfrm>
            <a:custGeom>
              <a:avLst/>
              <a:pathLst>
                <a:path w="503112" h="0">
                  <a:moveTo>
                    <a:pt x="5031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4712681" y="34154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5764195" y="2303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4488786" y="2303032"/>
              <a:ext cx="1275408" cy="0"/>
            </a:xfrm>
            <a:custGeom>
              <a:avLst/>
              <a:pathLst>
                <a:path w="1275408" h="0">
                  <a:moveTo>
                    <a:pt x="127540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4488786" y="2303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5637765" y="30181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4437133" y="3018176"/>
              <a:ext cx="1200632" cy="0"/>
            </a:xfrm>
            <a:custGeom>
              <a:avLst/>
              <a:pathLst>
                <a:path w="1200632" h="0">
                  <a:moveTo>
                    <a:pt x="12006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4437133" y="30181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5409379" y="2382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4824192" y="2382493"/>
              <a:ext cx="585186" cy="0"/>
            </a:xfrm>
            <a:custGeom>
              <a:avLst/>
              <a:pathLst>
                <a:path w="585186" h="0">
                  <a:moveTo>
                    <a:pt x="58518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4824192" y="2382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5906973" y="1270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4997601" y="1270046"/>
              <a:ext cx="909371" cy="0"/>
            </a:xfrm>
            <a:custGeom>
              <a:avLst/>
              <a:pathLst>
                <a:path w="909371" h="0">
                  <a:moveTo>
                    <a:pt x="90937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4997601" y="12700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5999781" y="15084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4723877" y="1508428"/>
              <a:ext cx="1275903" cy="0"/>
            </a:xfrm>
            <a:custGeom>
              <a:avLst/>
              <a:pathLst>
                <a:path w="1275903" h="0">
                  <a:moveTo>
                    <a:pt x="12759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4723877" y="15084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5163451" y="5163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3686009" y="5163609"/>
              <a:ext cx="1477441" cy="0"/>
            </a:xfrm>
            <a:custGeom>
              <a:avLst/>
              <a:pathLst>
                <a:path w="1477441" h="0">
                  <a:moveTo>
                    <a:pt x="14774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3686009" y="51636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5925418" y="21441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4432839" y="2144111"/>
              <a:ext cx="1492579" cy="0"/>
            </a:xfrm>
            <a:custGeom>
              <a:avLst/>
              <a:pathLst>
                <a:path w="1492579" h="0">
                  <a:moveTo>
                    <a:pt x="14925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4432839" y="21441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6012522" y="1746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4573249" y="1746809"/>
              <a:ext cx="1439273" cy="0"/>
            </a:xfrm>
            <a:custGeom>
              <a:avLst/>
              <a:pathLst>
                <a:path w="1439273" h="0">
                  <a:moveTo>
                    <a:pt x="14392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4573249" y="1746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5878408" y="1826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4677021" y="1826269"/>
              <a:ext cx="1201387" cy="0"/>
            </a:xfrm>
            <a:custGeom>
              <a:avLst/>
              <a:pathLst>
                <a:path w="1201387" h="0">
                  <a:moveTo>
                    <a:pt x="120138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4677021" y="1826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6161354" y="2064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4251353" y="2064651"/>
              <a:ext cx="1910001" cy="0"/>
            </a:xfrm>
            <a:custGeom>
              <a:avLst/>
              <a:pathLst>
                <a:path w="1910001" h="0">
                  <a:moveTo>
                    <a:pt x="19100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4251353" y="20646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5830042" y="2223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4432223" y="2223572"/>
              <a:ext cx="1397819" cy="0"/>
            </a:xfrm>
            <a:custGeom>
              <a:avLst/>
              <a:pathLst>
                <a:path w="1397819" h="0">
                  <a:moveTo>
                    <a:pt x="13978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4432223" y="22235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5040447" y="53225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3716297" y="5322529"/>
              <a:ext cx="1324150" cy="0"/>
            </a:xfrm>
            <a:custGeom>
              <a:avLst/>
              <a:pathLst>
                <a:path w="1324150" h="0">
                  <a:moveTo>
                    <a:pt x="13241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3716297" y="53225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5211639" y="3653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4522756" y="3653860"/>
              <a:ext cx="688882" cy="0"/>
            </a:xfrm>
            <a:custGeom>
              <a:avLst/>
              <a:pathLst>
                <a:path w="688882" h="0">
                  <a:moveTo>
                    <a:pt x="6888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4522756" y="36538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5478913" y="4051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4092427" y="4051162"/>
              <a:ext cx="1386485" cy="0"/>
            </a:xfrm>
            <a:custGeom>
              <a:avLst/>
              <a:pathLst>
                <a:path w="1386485" h="0">
                  <a:moveTo>
                    <a:pt x="138648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4092427" y="40511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6062098" y="1111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4971894" y="1111125"/>
              <a:ext cx="1090204" cy="0"/>
            </a:xfrm>
            <a:custGeom>
              <a:avLst/>
              <a:pathLst>
                <a:path w="1090204" h="0">
                  <a:moveTo>
                    <a:pt x="10902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4971894" y="11111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5027500" y="5401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3407911" y="5401990"/>
              <a:ext cx="1619588" cy="0"/>
            </a:xfrm>
            <a:custGeom>
              <a:avLst/>
              <a:pathLst>
                <a:path w="1619588" h="0">
                  <a:moveTo>
                    <a:pt x="161958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3407911" y="54019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5333477" y="3097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4699835" y="3097637"/>
              <a:ext cx="633642" cy="0"/>
            </a:xfrm>
            <a:custGeom>
              <a:avLst/>
              <a:pathLst>
                <a:path w="633642" h="0">
                  <a:moveTo>
                    <a:pt x="6336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4699835" y="3097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5397580" y="4369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4119964" y="4369004"/>
              <a:ext cx="1277615" cy="0"/>
            </a:xfrm>
            <a:custGeom>
              <a:avLst/>
              <a:pathLst>
                <a:path w="1277615" h="0">
                  <a:moveTo>
                    <a:pt x="127761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4119964" y="43690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5323165" y="44484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4144154" y="4448464"/>
              <a:ext cx="1179011" cy="0"/>
            </a:xfrm>
            <a:custGeom>
              <a:avLst/>
              <a:pathLst>
                <a:path w="1179011" h="0">
                  <a:moveTo>
                    <a:pt x="11790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4144154" y="44484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5590302" y="1985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4849352" y="1985190"/>
              <a:ext cx="740949" cy="0"/>
            </a:xfrm>
            <a:custGeom>
              <a:avLst/>
              <a:pathLst>
                <a:path w="740949" h="0">
                  <a:moveTo>
                    <a:pt x="7409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4849352" y="1985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5567856" y="2461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4658103" y="2461953"/>
              <a:ext cx="909753" cy="0"/>
            </a:xfrm>
            <a:custGeom>
              <a:avLst/>
              <a:pathLst>
                <a:path w="909753" h="0">
                  <a:moveTo>
                    <a:pt x="9097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4658103" y="24619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4997862" y="4130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4542323" y="4130623"/>
              <a:ext cx="455539" cy="0"/>
            </a:xfrm>
            <a:custGeom>
              <a:avLst/>
              <a:pathLst>
                <a:path w="455539" h="0">
                  <a:moveTo>
                    <a:pt x="4555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4542323" y="41306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5737292" y="2779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4394312" y="2779795"/>
              <a:ext cx="1342979" cy="0"/>
            </a:xfrm>
            <a:custGeom>
              <a:avLst/>
              <a:pathLst>
                <a:path w="1342979" h="0">
                  <a:moveTo>
                    <a:pt x="13429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4394312" y="2779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5228384" y="2620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4965106" y="2620874"/>
              <a:ext cx="263278" cy="0"/>
            </a:xfrm>
            <a:custGeom>
              <a:avLst/>
              <a:pathLst>
                <a:path w="263278" h="0">
                  <a:moveTo>
                    <a:pt x="26327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4965106" y="2620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5229726" y="3812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4407324" y="3812781"/>
              <a:ext cx="822402" cy="0"/>
            </a:xfrm>
            <a:custGeom>
              <a:avLst/>
              <a:pathLst>
                <a:path w="822402" h="0">
                  <a:moveTo>
                    <a:pt x="8224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4407324" y="38127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6003947" y="1905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4535734" y="1905730"/>
              <a:ext cx="1468212" cy="0"/>
            </a:xfrm>
            <a:custGeom>
              <a:avLst/>
              <a:pathLst>
                <a:path w="1468212" h="0">
                  <a:moveTo>
                    <a:pt x="14682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4535734" y="19057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5932852" y="2700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4222671" y="2700334"/>
              <a:ext cx="1710180" cy="0"/>
            </a:xfrm>
            <a:custGeom>
              <a:avLst/>
              <a:pathLst>
                <a:path w="1710180" h="0">
                  <a:moveTo>
                    <a:pt x="17101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4222671" y="2700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5342364" y="31770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4690538" y="3177097"/>
              <a:ext cx="651826" cy="0"/>
            </a:xfrm>
            <a:custGeom>
              <a:avLst/>
              <a:pathLst>
                <a:path w="651826" h="0">
                  <a:moveTo>
                    <a:pt x="65182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4690538" y="31770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6153833" y="14289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4590249" y="1428967"/>
              <a:ext cx="1563583" cy="0"/>
            </a:xfrm>
            <a:custGeom>
              <a:avLst/>
              <a:pathLst>
                <a:path w="1563583" h="0">
                  <a:moveTo>
                    <a:pt x="15635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4590249" y="14289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5833214" y="38922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3802483" y="3892241"/>
              <a:ext cx="2030731" cy="0"/>
            </a:xfrm>
            <a:custGeom>
              <a:avLst/>
              <a:pathLst>
                <a:path w="2030731" h="0">
                  <a:moveTo>
                    <a:pt x="20307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3802483" y="38922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5116111" y="4210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4411979" y="4210083"/>
              <a:ext cx="704131" cy="0"/>
            </a:xfrm>
            <a:custGeom>
              <a:avLst/>
              <a:pathLst>
                <a:path w="704131" h="0">
                  <a:moveTo>
                    <a:pt x="7041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4411979" y="4210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6156751" y="1190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4782060" y="1190586"/>
              <a:ext cx="1374690" cy="0"/>
            </a:xfrm>
            <a:custGeom>
              <a:avLst/>
              <a:pathLst>
                <a:path w="1374690" h="0">
                  <a:moveTo>
                    <a:pt x="137469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4782060" y="11905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5379610" y="35743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4400355" y="3574399"/>
              <a:ext cx="979255" cy="0"/>
            </a:xfrm>
            <a:custGeom>
              <a:avLst/>
              <a:pathLst>
                <a:path w="979255" h="0">
                  <a:moveTo>
                    <a:pt x="97925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4400355" y="35743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5642142" y="2938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4464105" y="2938716"/>
              <a:ext cx="1178037" cy="0"/>
            </a:xfrm>
            <a:custGeom>
              <a:avLst/>
              <a:pathLst>
                <a:path w="1178037" h="0">
                  <a:moveTo>
                    <a:pt x="11780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4464105" y="2938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5069402" y="4925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4106853" y="4925227"/>
              <a:ext cx="962548" cy="0"/>
            </a:xfrm>
            <a:custGeom>
              <a:avLst/>
              <a:pathLst>
                <a:path w="962548" h="0">
                  <a:moveTo>
                    <a:pt x="9625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4106853" y="4925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5195886" y="50841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3718604" y="5084148"/>
              <a:ext cx="1477282" cy="0"/>
            </a:xfrm>
            <a:custGeom>
              <a:avLst/>
              <a:pathLst>
                <a:path w="1477282" h="0">
                  <a:moveTo>
                    <a:pt x="147728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3718604" y="50841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5099283" y="4766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4130542" y="4766306"/>
              <a:ext cx="968741" cy="0"/>
            </a:xfrm>
            <a:custGeom>
              <a:avLst/>
              <a:pathLst>
                <a:path w="968741" h="0">
                  <a:moveTo>
                    <a:pt x="9687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4130542" y="4766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4850055" y="50046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4079936" y="5004688"/>
              <a:ext cx="770119" cy="0"/>
            </a:xfrm>
            <a:custGeom>
              <a:avLst/>
              <a:pathLst>
                <a:path w="770119" h="0">
                  <a:moveTo>
                    <a:pt x="7701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4079936" y="50046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4705120" y="56403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3308167" y="5640371"/>
              <a:ext cx="1396953" cy="0"/>
            </a:xfrm>
            <a:custGeom>
              <a:avLst/>
              <a:pathLst>
                <a:path w="1396953" h="0">
                  <a:moveTo>
                    <a:pt x="13969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3308167" y="56403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5442671" y="4686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3903301" y="4686846"/>
              <a:ext cx="1539370" cy="0"/>
            </a:xfrm>
            <a:custGeom>
              <a:avLst/>
              <a:pathLst>
                <a:path w="1539370" h="0">
                  <a:moveTo>
                    <a:pt x="15393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3903301" y="46868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5669598" y="3733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3995544" y="3733320"/>
              <a:ext cx="1674053" cy="0"/>
            </a:xfrm>
            <a:custGeom>
              <a:avLst/>
              <a:pathLst>
                <a:path w="1674053" h="0">
                  <a:moveTo>
                    <a:pt x="167405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3995544" y="3733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6004457" y="1667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4582099" y="1667348"/>
              <a:ext cx="1422358" cy="0"/>
            </a:xfrm>
            <a:custGeom>
              <a:avLst/>
              <a:pathLst>
                <a:path w="1422358" h="0">
                  <a:moveTo>
                    <a:pt x="14223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4582099" y="166734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5005976" y="5481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3192492" y="5481450"/>
              <a:ext cx="1813484" cy="0"/>
            </a:xfrm>
            <a:custGeom>
              <a:avLst/>
              <a:pathLst>
                <a:path w="1813484" h="0">
                  <a:moveTo>
                    <a:pt x="18134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3192492" y="54814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5774613" y="32565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4252936" y="3256558"/>
              <a:ext cx="1521676" cy="0"/>
            </a:xfrm>
            <a:custGeom>
              <a:avLst/>
              <a:pathLst>
                <a:path w="1521676" h="0">
                  <a:moveTo>
                    <a:pt x="15216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4252936" y="32565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5036011" y="5878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4896702" y="5878753"/>
              <a:ext cx="139308" cy="0"/>
            </a:xfrm>
            <a:custGeom>
              <a:avLst/>
              <a:pathLst>
                <a:path w="139308" h="0">
                  <a:moveTo>
                    <a:pt x="139308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4896702" y="5878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5157051" y="5799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4902412" y="5799292"/>
              <a:ext cx="254639" cy="0"/>
            </a:xfrm>
            <a:custGeom>
              <a:avLst/>
              <a:pathLst>
                <a:path w="254639" h="0">
                  <a:moveTo>
                    <a:pt x="254639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4902412" y="5799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t261"/>
            <p:cNvSpPr/>
            <p:nvPr/>
          </p:nvSpPr>
          <p:spPr>
            <a:xfrm>
              <a:off x="4571595" y="48209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t262"/>
            <p:cNvSpPr/>
            <p:nvPr/>
          </p:nvSpPr>
          <p:spPr>
            <a:xfrm>
              <a:off x="5028777" y="28344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t263"/>
            <p:cNvSpPr/>
            <p:nvPr/>
          </p:nvSpPr>
          <p:spPr>
            <a:xfrm>
              <a:off x="4951843" y="331119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t264"/>
            <p:cNvSpPr/>
            <p:nvPr/>
          </p:nvSpPr>
          <p:spPr>
            <a:xfrm>
              <a:off x="4062341" y="55360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t265"/>
            <p:cNvSpPr/>
            <p:nvPr/>
          </p:nvSpPr>
          <p:spPr>
            <a:xfrm>
              <a:off x="4372515" y="52182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t266"/>
            <p:cNvSpPr/>
            <p:nvPr/>
          </p:nvSpPr>
          <p:spPr>
            <a:xfrm>
              <a:off x="4926320" y="34701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t267"/>
            <p:cNvSpPr/>
            <p:nvPr/>
          </p:nvSpPr>
          <p:spPr>
            <a:xfrm>
              <a:off x="5073848" y="25165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t268"/>
            <p:cNvSpPr/>
            <p:nvPr/>
          </p:nvSpPr>
          <p:spPr>
            <a:xfrm>
              <a:off x="4649821" y="45825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t269"/>
            <p:cNvSpPr/>
            <p:nvPr/>
          </p:nvSpPr>
          <p:spPr>
            <a:xfrm>
              <a:off x="4737997" y="42647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t270"/>
            <p:cNvSpPr/>
            <p:nvPr/>
          </p:nvSpPr>
          <p:spPr>
            <a:xfrm>
              <a:off x="5525743" y="10068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t271"/>
            <p:cNvSpPr/>
            <p:nvPr/>
          </p:nvSpPr>
          <p:spPr>
            <a:xfrm>
              <a:off x="5286468" y="15630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t272"/>
            <p:cNvSpPr/>
            <p:nvPr/>
          </p:nvSpPr>
          <p:spPr>
            <a:xfrm>
              <a:off x="5389879" y="13246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t273"/>
            <p:cNvSpPr/>
            <p:nvPr/>
          </p:nvSpPr>
          <p:spPr>
            <a:xfrm>
              <a:off x="4776658" y="3946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t274"/>
            <p:cNvSpPr/>
            <p:nvPr/>
          </p:nvSpPr>
          <p:spPr>
            <a:xfrm>
              <a:off x="4665940" y="45030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t275"/>
            <p:cNvSpPr/>
            <p:nvPr/>
          </p:nvSpPr>
          <p:spPr>
            <a:xfrm>
              <a:off x="4939412" y="33906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t276"/>
            <p:cNvSpPr/>
            <p:nvPr/>
          </p:nvSpPr>
          <p:spPr>
            <a:xfrm>
              <a:off x="5101665" y="22782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t277"/>
            <p:cNvSpPr/>
            <p:nvPr/>
          </p:nvSpPr>
          <p:spPr>
            <a:xfrm>
              <a:off x="5012623" y="29933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t278"/>
            <p:cNvSpPr/>
            <p:nvPr/>
          </p:nvSpPr>
          <p:spPr>
            <a:xfrm>
              <a:off x="5091960" y="23576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t279"/>
            <p:cNvSpPr/>
            <p:nvPr/>
          </p:nvSpPr>
          <p:spPr>
            <a:xfrm>
              <a:off x="5427461" y="12452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t280"/>
            <p:cNvSpPr/>
            <p:nvPr/>
          </p:nvSpPr>
          <p:spPr>
            <a:xfrm>
              <a:off x="5337003" y="14836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t281"/>
            <p:cNvSpPr/>
            <p:nvPr/>
          </p:nvSpPr>
          <p:spPr>
            <a:xfrm>
              <a:off x="4399904" y="51387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t282"/>
            <p:cNvSpPr/>
            <p:nvPr/>
          </p:nvSpPr>
          <p:spPr>
            <a:xfrm>
              <a:off x="5154302" y="21192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t283"/>
            <p:cNvSpPr/>
            <p:nvPr/>
          </p:nvSpPr>
          <p:spPr>
            <a:xfrm>
              <a:off x="5268060" y="17219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t284"/>
            <p:cNvSpPr/>
            <p:nvPr/>
          </p:nvSpPr>
          <p:spPr>
            <a:xfrm>
              <a:off x="5252888" y="18014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t285"/>
            <p:cNvSpPr/>
            <p:nvPr/>
          </p:nvSpPr>
          <p:spPr>
            <a:xfrm>
              <a:off x="5181527" y="20398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t286"/>
            <p:cNvSpPr/>
            <p:nvPr/>
          </p:nvSpPr>
          <p:spPr>
            <a:xfrm>
              <a:off x="5106306" y="21987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t287"/>
            <p:cNvSpPr/>
            <p:nvPr/>
          </p:nvSpPr>
          <p:spPr>
            <a:xfrm>
              <a:off x="4353546" y="52977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t288"/>
            <p:cNvSpPr/>
            <p:nvPr/>
          </p:nvSpPr>
          <p:spPr>
            <a:xfrm>
              <a:off x="4842372" y="36290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t289"/>
            <p:cNvSpPr/>
            <p:nvPr/>
          </p:nvSpPr>
          <p:spPr>
            <a:xfrm>
              <a:off x="4760844" y="40263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t290"/>
            <p:cNvSpPr/>
            <p:nvPr/>
          </p:nvSpPr>
          <p:spPr>
            <a:xfrm>
              <a:off x="5492170" y="10862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t291"/>
            <p:cNvSpPr/>
            <p:nvPr/>
          </p:nvSpPr>
          <p:spPr>
            <a:xfrm>
              <a:off x="4192879" y="53771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t292"/>
            <p:cNvSpPr/>
            <p:nvPr/>
          </p:nvSpPr>
          <p:spPr>
            <a:xfrm>
              <a:off x="4991830" y="30728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t293"/>
            <p:cNvSpPr/>
            <p:nvPr/>
          </p:nvSpPr>
          <p:spPr>
            <a:xfrm>
              <a:off x="4733946" y="43441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t294"/>
            <p:cNvSpPr/>
            <p:nvPr/>
          </p:nvSpPr>
          <p:spPr>
            <a:xfrm>
              <a:off x="4708834" y="44236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t295"/>
            <p:cNvSpPr/>
            <p:nvPr/>
          </p:nvSpPr>
          <p:spPr>
            <a:xfrm>
              <a:off x="5195001" y="19603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t296"/>
            <p:cNvSpPr/>
            <p:nvPr/>
          </p:nvSpPr>
          <p:spPr>
            <a:xfrm>
              <a:off x="5088153" y="243712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t297"/>
            <p:cNvSpPr/>
            <p:nvPr/>
          </p:nvSpPr>
          <p:spPr>
            <a:xfrm>
              <a:off x="4745266" y="41057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t298"/>
            <p:cNvSpPr/>
            <p:nvPr/>
          </p:nvSpPr>
          <p:spPr>
            <a:xfrm>
              <a:off x="5040976" y="27549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t299"/>
            <p:cNvSpPr/>
            <p:nvPr/>
          </p:nvSpPr>
          <p:spPr>
            <a:xfrm>
              <a:off x="5071919" y="25960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t300"/>
            <p:cNvSpPr/>
            <p:nvPr/>
          </p:nvSpPr>
          <p:spPr>
            <a:xfrm>
              <a:off x="4793699" y="37879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t301"/>
            <p:cNvSpPr/>
            <p:nvPr/>
          </p:nvSpPr>
          <p:spPr>
            <a:xfrm>
              <a:off x="5245015" y="18809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t302"/>
            <p:cNvSpPr/>
            <p:nvPr/>
          </p:nvSpPr>
          <p:spPr>
            <a:xfrm>
              <a:off x="5052936" y="26755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t303"/>
            <p:cNvSpPr/>
            <p:nvPr/>
          </p:nvSpPr>
          <p:spPr>
            <a:xfrm>
              <a:off x="4991625" y="31522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t304"/>
            <p:cNvSpPr/>
            <p:nvPr/>
          </p:nvSpPr>
          <p:spPr>
            <a:xfrm>
              <a:off x="5347215" y="14041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t305"/>
            <p:cNvSpPr/>
            <p:nvPr/>
          </p:nvSpPr>
          <p:spPr>
            <a:xfrm>
              <a:off x="4793023" y="38674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t306"/>
            <p:cNvSpPr/>
            <p:nvPr/>
          </p:nvSpPr>
          <p:spPr>
            <a:xfrm>
              <a:off x="4739219" y="41852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t307"/>
            <p:cNvSpPr/>
            <p:nvPr/>
          </p:nvSpPr>
          <p:spPr>
            <a:xfrm>
              <a:off x="5444580" y="11657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t308"/>
            <p:cNvSpPr/>
            <p:nvPr/>
          </p:nvSpPr>
          <p:spPr>
            <a:xfrm>
              <a:off x="4865156" y="35495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t309"/>
            <p:cNvSpPr/>
            <p:nvPr/>
          </p:nvSpPr>
          <p:spPr>
            <a:xfrm>
              <a:off x="5028298" y="29138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t310"/>
            <p:cNvSpPr/>
            <p:nvPr/>
          </p:nvSpPr>
          <p:spPr>
            <a:xfrm>
              <a:off x="4563302" y="49004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t311"/>
            <p:cNvSpPr/>
            <p:nvPr/>
          </p:nvSpPr>
          <p:spPr>
            <a:xfrm>
              <a:off x="4432419" y="505932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t312"/>
            <p:cNvSpPr/>
            <p:nvPr/>
          </p:nvSpPr>
          <p:spPr>
            <a:xfrm>
              <a:off x="4590087" y="47414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t313"/>
            <p:cNvSpPr/>
            <p:nvPr/>
          </p:nvSpPr>
          <p:spPr>
            <a:xfrm>
              <a:off x="4440170" y="497986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t314"/>
            <p:cNvSpPr/>
            <p:nvPr/>
          </p:nvSpPr>
          <p:spPr>
            <a:xfrm>
              <a:off x="3981817" y="56155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t315"/>
            <p:cNvSpPr/>
            <p:nvPr/>
          </p:nvSpPr>
          <p:spPr>
            <a:xfrm>
              <a:off x="4648160" y="46620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t316"/>
            <p:cNvSpPr/>
            <p:nvPr/>
          </p:nvSpPr>
          <p:spPr>
            <a:xfrm>
              <a:off x="4807745" y="37084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t317"/>
            <p:cNvSpPr/>
            <p:nvPr/>
          </p:nvSpPr>
          <p:spPr>
            <a:xfrm>
              <a:off x="5268452" y="16425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t318"/>
            <p:cNvSpPr/>
            <p:nvPr/>
          </p:nvSpPr>
          <p:spPr>
            <a:xfrm>
              <a:off x="4074408" y="54566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t319"/>
            <p:cNvSpPr/>
            <p:nvPr/>
          </p:nvSpPr>
          <p:spPr>
            <a:xfrm>
              <a:off x="4988949" y="32317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t320"/>
            <p:cNvSpPr/>
            <p:nvPr/>
          </p:nvSpPr>
          <p:spPr>
            <a:xfrm>
              <a:off x="4941531" y="5853927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t321"/>
            <p:cNvSpPr/>
            <p:nvPr/>
          </p:nvSpPr>
          <p:spPr>
            <a:xfrm>
              <a:off x="5004906" y="5774466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2594369" y="57198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tx323"/>
            <p:cNvSpPr/>
            <p:nvPr/>
          </p:nvSpPr>
          <p:spPr>
            <a:xfrm>
              <a:off x="1148183" y="5821007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325" name="tx324"/>
            <p:cNvSpPr/>
            <p:nvPr/>
          </p:nvSpPr>
          <p:spPr>
            <a:xfrm>
              <a:off x="1871190" y="5741547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326" name="tx325"/>
            <p:cNvSpPr/>
            <p:nvPr/>
          </p:nvSpPr>
          <p:spPr>
            <a:xfrm>
              <a:off x="2051570" y="560242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02925</a:t>
              </a:r>
            </a:p>
          </p:txBody>
        </p:sp>
        <p:sp>
          <p:nvSpPr>
            <p:cNvPr id="327" name="tx326"/>
            <p:cNvSpPr/>
            <p:nvPr/>
          </p:nvSpPr>
          <p:spPr>
            <a:xfrm>
              <a:off x="1938559" y="5523009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214565</a:t>
              </a:r>
            </a:p>
          </p:txBody>
        </p:sp>
        <p:sp>
          <p:nvSpPr>
            <p:cNvPr id="328" name="tx327"/>
            <p:cNvSpPr/>
            <p:nvPr/>
          </p:nvSpPr>
          <p:spPr>
            <a:xfrm>
              <a:off x="2051570" y="544349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52306</a:t>
              </a:r>
            </a:p>
          </p:txBody>
        </p:sp>
        <p:sp>
          <p:nvSpPr>
            <p:cNvPr id="329" name="tx328"/>
            <p:cNvSpPr/>
            <p:nvPr/>
          </p:nvSpPr>
          <p:spPr>
            <a:xfrm>
              <a:off x="2051570" y="536408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26590</a:t>
              </a:r>
            </a:p>
          </p:txBody>
        </p:sp>
        <p:sp>
          <p:nvSpPr>
            <p:cNvPr id="330" name="tx329"/>
            <p:cNvSpPr/>
            <p:nvPr/>
          </p:nvSpPr>
          <p:spPr>
            <a:xfrm>
              <a:off x="2108075" y="5284628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5749</a:t>
              </a:r>
            </a:p>
          </p:txBody>
        </p:sp>
        <p:sp>
          <p:nvSpPr>
            <p:cNvPr id="331" name="tx330"/>
            <p:cNvSpPr/>
            <p:nvPr/>
          </p:nvSpPr>
          <p:spPr>
            <a:xfrm>
              <a:off x="1995065" y="520511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396409</a:t>
              </a:r>
            </a:p>
          </p:txBody>
        </p:sp>
        <p:sp>
          <p:nvSpPr>
            <p:cNvPr id="332" name="tx331"/>
            <p:cNvSpPr/>
            <p:nvPr/>
          </p:nvSpPr>
          <p:spPr>
            <a:xfrm>
              <a:off x="2051570" y="51257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57291</a:t>
              </a:r>
            </a:p>
          </p:txBody>
        </p:sp>
        <p:sp>
          <p:nvSpPr>
            <p:cNvPr id="333" name="tx332"/>
            <p:cNvSpPr/>
            <p:nvPr/>
          </p:nvSpPr>
          <p:spPr>
            <a:xfrm>
              <a:off x="2108075" y="5046197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6364</a:t>
              </a:r>
            </a:p>
          </p:txBody>
        </p:sp>
        <p:sp>
          <p:nvSpPr>
            <p:cNvPr id="334" name="tx333"/>
            <p:cNvSpPr/>
            <p:nvPr/>
          </p:nvSpPr>
          <p:spPr>
            <a:xfrm>
              <a:off x="2051570" y="496678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24610</a:t>
              </a:r>
            </a:p>
          </p:txBody>
        </p:sp>
        <p:sp>
          <p:nvSpPr>
            <p:cNvPr id="335" name="tx334"/>
            <p:cNvSpPr/>
            <p:nvPr/>
          </p:nvSpPr>
          <p:spPr>
            <a:xfrm>
              <a:off x="2051570" y="488732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25697</a:t>
              </a:r>
            </a:p>
          </p:txBody>
        </p:sp>
        <p:sp>
          <p:nvSpPr>
            <p:cNvPr id="336" name="tx335"/>
            <p:cNvSpPr/>
            <p:nvPr/>
          </p:nvSpPr>
          <p:spPr>
            <a:xfrm>
              <a:off x="2051570" y="480786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1409</a:t>
              </a:r>
            </a:p>
          </p:txBody>
        </p:sp>
        <p:sp>
          <p:nvSpPr>
            <p:cNvPr id="337" name="tx336"/>
            <p:cNvSpPr/>
            <p:nvPr/>
          </p:nvSpPr>
          <p:spPr>
            <a:xfrm>
              <a:off x="2051570" y="472840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88156</a:t>
              </a:r>
            </a:p>
          </p:txBody>
        </p:sp>
        <p:sp>
          <p:nvSpPr>
            <p:cNvPr id="338" name="tx337"/>
            <p:cNvSpPr/>
            <p:nvPr/>
          </p:nvSpPr>
          <p:spPr>
            <a:xfrm>
              <a:off x="1995065" y="464889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349296</a:t>
              </a:r>
            </a:p>
          </p:txBody>
        </p:sp>
        <p:sp>
          <p:nvSpPr>
            <p:cNvPr id="339" name="tx338"/>
            <p:cNvSpPr/>
            <p:nvPr/>
          </p:nvSpPr>
          <p:spPr>
            <a:xfrm>
              <a:off x="1995065" y="4569434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96443</a:t>
              </a:r>
            </a:p>
          </p:txBody>
        </p:sp>
        <p:sp>
          <p:nvSpPr>
            <p:cNvPr id="340" name="tx339"/>
            <p:cNvSpPr/>
            <p:nvPr/>
          </p:nvSpPr>
          <p:spPr>
            <a:xfrm>
              <a:off x="1938559" y="4490023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8179165</a:t>
              </a:r>
            </a:p>
          </p:txBody>
        </p:sp>
        <p:sp>
          <p:nvSpPr>
            <p:cNvPr id="341" name="tx340"/>
            <p:cNvSpPr/>
            <p:nvPr/>
          </p:nvSpPr>
          <p:spPr>
            <a:xfrm>
              <a:off x="2051570" y="441051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212198</a:t>
              </a:r>
            </a:p>
          </p:txBody>
        </p:sp>
        <p:sp>
          <p:nvSpPr>
            <p:cNvPr id="342" name="tx341"/>
            <p:cNvSpPr/>
            <p:nvPr/>
          </p:nvSpPr>
          <p:spPr>
            <a:xfrm>
              <a:off x="2051570" y="4331053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16068</a:t>
              </a:r>
            </a:p>
          </p:txBody>
        </p:sp>
        <p:sp>
          <p:nvSpPr>
            <p:cNvPr id="343" name="tx342"/>
            <p:cNvSpPr/>
            <p:nvPr/>
          </p:nvSpPr>
          <p:spPr>
            <a:xfrm>
              <a:off x="1995065" y="425159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105304</a:t>
              </a:r>
            </a:p>
          </p:txBody>
        </p:sp>
        <p:sp>
          <p:nvSpPr>
            <p:cNvPr id="344" name="tx343"/>
            <p:cNvSpPr/>
            <p:nvPr/>
          </p:nvSpPr>
          <p:spPr>
            <a:xfrm>
              <a:off x="2108075" y="4172182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89852</a:t>
              </a:r>
            </a:p>
          </p:txBody>
        </p:sp>
        <p:sp>
          <p:nvSpPr>
            <p:cNvPr id="345" name="tx344"/>
            <p:cNvSpPr/>
            <p:nvPr/>
          </p:nvSpPr>
          <p:spPr>
            <a:xfrm>
              <a:off x="1995065" y="409267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523212</a:t>
              </a:r>
            </a:p>
          </p:txBody>
        </p:sp>
        <p:sp>
          <p:nvSpPr>
            <p:cNvPr id="346" name="tx345"/>
            <p:cNvSpPr/>
            <p:nvPr/>
          </p:nvSpPr>
          <p:spPr>
            <a:xfrm>
              <a:off x="2051570" y="4013261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788144</a:t>
              </a:r>
            </a:p>
          </p:txBody>
        </p:sp>
        <p:sp>
          <p:nvSpPr>
            <p:cNvPr id="347" name="tx346"/>
            <p:cNvSpPr/>
            <p:nvPr/>
          </p:nvSpPr>
          <p:spPr>
            <a:xfrm>
              <a:off x="1938559" y="3933800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40885868</a:t>
              </a:r>
            </a:p>
          </p:txBody>
        </p:sp>
        <p:sp>
          <p:nvSpPr>
            <p:cNvPr id="348" name="tx347"/>
            <p:cNvSpPr/>
            <p:nvPr/>
          </p:nvSpPr>
          <p:spPr>
            <a:xfrm>
              <a:off x="1995065" y="385429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6379622</a:t>
              </a:r>
            </a:p>
          </p:txBody>
        </p:sp>
        <p:sp>
          <p:nvSpPr>
            <p:cNvPr id="349" name="tx348"/>
            <p:cNvSpPr/>
            <p:nvPr/>
          </p:nvSpPr>
          <p:spPr>
            <a:xfrm>
              <a:off x="2051570" y="3775177"/>
              <a:ext cx="480169" cy="739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75545</a:t>
              </a:r>
            </a:p>
          </p:txBody>
        </p:sp>
        <p:sp>
          <p:nvSpPr>
            <p:cNvPr id="350" name="tx349"/>
            <p:cNvSpPr/>
            <p:nvPr/>
          </p:nvSpPr>
          <p:spPr>
            <a:xfrm>
              <a:off x="2108075" y="3695419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4600</a:t>
              </a:r>
            </a:p>
          </p:txBody>
        </p:sp>
        <p:sp>
          <p:nvSpPr>
            <p:cNvPr id="351" name="tx350"/>
            <p:cNvSpPr/>
            <p:nvPr/>
          </p:nvSpPr>
          <p:spPr>
            <a:xfrm>
              <a:off x="2051570" y="361595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581824</a:t>
              </a:r>
            </a:p>
          </p:txBody>
        </p:sp>
        <p:sp>
          <p:nvSpPr>
            <p:cNvPr id="352" name="tx351"/>
            <p:cNvSpPr/>
            <p:nvPr/>
          </p:nvSpPr>
          <p:spPr>
            <a:xfrm>
              <a:off x="2051570" y="353649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29747</a:t>
              </a:r>
            </a:p>
          </p:txBody>
        </p:sp>
        <p:sp>
          <p:nvSpPr>
            <p:cNvPr id="353" name="tx352"/>
            <p:cNvSpPr/>
            <p:nvPr/>
          </p:nvSpPr>
          <p:spPr>
            <a:xfrm>
              <a:off x="1938559" y="3457037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158982</a:t>
              </a:r>
            </a:p>
          </p:txBody>
        </p:sp>
        <p:sp>
          <p:nvSpPr>
            <p:cNvPr id="354" name="tx353"/>
            <p:cNvSpPr/>
            <p:nvPr/>
          </p:nvSpPr>
          <p:spPr>
            <a:xfrm>
              <a:off x="1938559" y="3377577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0147865</a:t>
              </a:r>
            </a:p>
          </p:txBody>
        </p:sp>
        <p:sp>
          <p:nvSpPr>
            <p:cNvPr id="355" name="tx354"/>
            <p:cNvSpPr/>
            <p:nvPr/>
          </p:nvSpPr>
          <p:spPr>
            <a:xfrm>
              <a:off x="1995065" y="329806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02328</a:t>
              </a:r>
            </a:p>
          </p:txBody>
        </p:sp>
        <p:sp>
          <p:nvSpPr>
            <p:cNvPr id="356" name="tx355"/>
            <p:cNvSpPr/>
            <p:nvPr/>
          </p:nvSpPr>
          <p:spPr>
            <a:xfrm>
              <a:off x="2108075" y="321860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31036</a:t>
              </a:r>
            </a:p>
          </p:txBody>
        </p:sp>
        <p:sp>
          <p:nvSpPr>
            <p:cNvPr id="357" name="tx356"/>
            <p:cNvSpPr/>
            <p:nvPr/>
          </p:nvSpPr>
          <p:spPr>
            <a:xfrm>
              <a:off x="2051570" y="313919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66019</a:t>
              </a:r>
            </a:p>
          </p:txBody>
        </p:sp>
        <p:sp>
          <p:nvSpPr>
            <p:cNvPr id="358" name="tx357"/>
            <p:cNvSpPr/>
            <p:nvPr/>
          </p:nvSpPr>
          <p:spPr>
            <a:xfrm>
              <a:off x="2051570" y="305973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41484</a:t>
              </a:r>
            </a:p>
          </p:txBody>
        </p:sp>
        <p:sp>
          <p:nvSpPr>
            <p:cNvPr id="359" name="tx358"/>
            <p:cNvSpPr/>
            <p:nvPr/>
          </p:nvSpPr>
          <p:spPr>
            <a:xfrm>
              <a:off x="1995065" y="298022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013743</a:t>
              </a:r>
            </a:p>
          </p:txBody>
        </p:sp>
        <p:sp>
          <p:nvSpPr>
            <p:cNvPr id="360" name="tx359"/>
            <p:cNvSpPr/>
            <p:nvPr/>
          </p:nvSpPr>
          <p:spPr>
            <a:xfrm>
              <a:off x="2051570" y="290081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04946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1995065" y="282135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886117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2051570" y="274184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45534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2051570" y="266243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9278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1995065" y="258297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499402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2051570" y="250351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1614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1995065" y="2424002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555420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1995065" y="234459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592117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1938559" y="2265081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50386926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2051570" y="218562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37817</a:t>
              </a:r>
            </a:p>
          </p:txBody>
        </p:sp>
        <p:sp>
          <p:nvSpPr>
            <p:cNvPr id="370" name="tx369"/>
            <p:cNvSpPr/>
            <p:nvPr/>
          </p:nvSpPr>
          <p:spPr>
            <a:xfrm>
              <a:off x="2051570" y="210621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60824</a:t>
              </a:r>
            </a:p>
          </p:txBody>
        </p:sp>
        <p:sp>
          <p:nvSpPr>
            <p:cNvPr id="371" name="tx370"/>
            <p:cNvSpPr/>
            <p:nvPr/>
          </p:nvSpPr>
          <p:spPr>
            <a:xfrm>
              <a:off x="2051570" y="20267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36958</a:t>
              </a:r>
            </a:p>
          </p:txBody>
        </p:sp>
        <p:sp>
          <p:nvSpPr>
            <p:cNvPr id="372" name="tx371"/>
            <p:cNvSpPr/>
            <p:nvPr/>
          </p:nvSpPr>
          <p:spPr>
            <a:xfrm>
              <a:off x="1995065" y="194723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381009</a:t>
              </a:r>
            </a:p>
          </p:txBody>
        </p:sp>
        <p:sp>
          <p:nvSpPr>
            <p:cNvPr id="373" name="tx372"/>
            <p:cNvSpPr/>
            <p:nvPr/>
          </p:nvSpPr>
          <p:spPr>
            <a:xfrm>
              <a:off x="2051570" y="18677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3505</a:t>
              </a:r>
            </a:p>
          </p:txBody>
        </p:sp>
        <p:sp>
          <p:nvSpPr>
            <p:cNvPr id="374" name="tx373"/>
            <p:cNvSpPr/>
            <p:nvPr/>
          </p:nvSpPr>
          <p:spPr>
            <a:xfrm>
              <a:off x="2051570" y="1788318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31145</a:t>
              </a:r>
            </a:p>
          </p:txBody>
        </p:sp>
        <p:sp>
          <p:nvSpPr>
            <p:cNvPr id="375" name="tx374"/>
            <p:cNvSpPr/>
            <p:nvPr/>
          </p:nvSpPr>
          <p:spPr>
            <a:xfrm>
              <a:off x="2051570" y="170890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95525</a:t>
              </a:r>
            </a:p>
          </p:txBody>
        </p:sp>
        <p:sp>
          <p:nvSpPr>
            <p:cNvPr id="376" name="tx375"/>
            <p:cNvSpPr/>
            <p:nvPr/>
          </p:nvSpPr>
          <p:spPr>
            <a:xfrm>
              <a:off x="2051570" y="162944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696556</a:t>
              </a:r>
            </a:p>
          </p:txBody>
        </p:sp>
        <p:sp>
          <p:nvSpPr>
            <p:cNvPr id="377" name="tx376"/>
            <p:cNvSpPr/>
            <p:nvPr/>
          </p:nvSpPr>
          <p:spPr>
            <a:xfrm>
              <a:off x="1995065" y="154998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87661</a:t>
              </a:r>
            </a:p>
          </p:txBody>
        </p:sp>
        <p:sp>
          <p:nvSpPr>
            <p:cNvPr id="378" name="tx377"/>
            <p:cNvSpPr/>
            <p:nvPr/>
          </p:nvSpPr>
          <p:spPr>
            <a:xfrm>
              <a:off x="1938559" y="1470526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0419650</a:t>
              </a:r>
            </a:p>
          </p:txBody>
        </p:sp>
        <p:sp>
          <p:nvSpPr>
            <p:cNvPr id="379" name="tx378"/>
            <p:cNvSpPr/>
            <p:nvPr/>
          </p:nvSpPr>
          <p:spPr>
            <a:xfrm>
              <a:off x="2108075" y="139106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6708</a:t>
              </a:r>
            </a:p>
          </p:txBody>
        </p:sp>
        <p:sp>
          <p:nvSpPr>
            <p:cNvPr id="380" name="tx379"/>
            <p:cNvSpPr/>
            <p:nvPr/>
          </p:nvSpPr>
          <p:spPr>
            <a:xfrm>
              <a:off x="1995065" y="131155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411042</a:t>
              </a:r>
            </a:p>
          </p:txBody>
        </p:sp>
        <p:sp>
          <p:nvSpPr>
            <p:cNvPr id="381" name="tx380"/>
            <p:cNvSpPr/>
            <p:nvPr/>
          </p:nvSpPr>
          <p:spPr>
            <a:xfrm>
              <a:off x="1995065" y="123214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786744</a:t>
              </a:r>
            </a:p>
          </p:txBody>
        </p:sp>
        <p:sp>
          <p:nvSpPr>
            <p:cNvPr id="382" name="tx381"/>
            <p:cNvSpPr/>
            <p:nvPr/>
          </p:nvSpPr>
          <p:spPr>
            <a:xfrm>
              <a:off x="1995065" y="115268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941404</a:t>
              </a:r>
            </a:p>
          </p:txBody>
        </p:sp>
        <p:sp>
          <p:nvSpPr>
            <p:cNvPr id="383" name="tx382"/>
            <p:cNvSpPr/>
            <p:nvPr/>
          </p:nvSpPr>
          <p:spPr>
            <a:xfrm>
              <a:off x="1995065" y="107322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517717</a:t>
              </a:r>
            </a:p>
          </p:txBody>
        </p:sp>
        <p:sp>
          <p:nvSpPr>
            <p:cNvPr id="384" name="tx383"/>
            <p:cNvSpPr/>
            <p:nvPr/>
          </p:nvSpPr>
          <p:spPr>
            <a:xfrm>
              <a:off x="1995065" y="99376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575710</a:t>
              </a:r>
            </a:p>
          </p:txBody>
        </p:sp>
        <p:sp>
          <p:nvSpPr>
            <p:cNvPr id="385" name="pl384"/>
            <p:cNvSpPr/>
            <p:nvPr/>
          </p:nvSpPr>
          <p:spPr>
            <a:xfrm>
              <a:off x="2559574" y="58787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2559574" y="57992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2559574" y="57198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2559574" y="564037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2559574" y="55609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2559574" y="54814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2559574" y="54019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2559574" y="53225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2559574" y="52430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2559574" y="51636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2559574" y="50841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2559574" y="50046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2559574" y="49252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2559574" y="48457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2559574" y="47663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2559574" y="46868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2559574" y="46073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2559574" y="45279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2559574" y="44484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2559574" y="43690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2559574" y="42895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2559574" y="42100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2559574" y="413062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2559574" y="40511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2559574" y="39717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2559574" y="389224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2559574" y="38127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2559574" y="37333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2559574" y="36538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2559574" y="35743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2559574" y="34949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2559574" y="34154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2559574" y="333601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2559574" y="32565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2559574" y="31770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2559574" y="30976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2559574" y="30181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2559574" y="293871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2559574" y="28592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2559574" y="27797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2559574" y="27003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2559574" y="26208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2559574" y="25414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2559574" y="246195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2559574" y="238249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2559574" y="23030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2559574" y="22235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2559574" y="21441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2559574" y="20646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2559574" y="19851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2559574" y="19057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2559574" y="18262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2559574" y="17468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2559574" y="166734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2559574" y="15878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2559574" y="15084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2559574" y="14289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2559574" y="13495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2559574" y="12700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2559574" y="119058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2559574" y="11111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2559574" y="10316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3224072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404783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487159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569535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tx450"/>
            <p:cNvSpPr/>
            <p:nvPr/>
          </p:nvSpPr>
          <p:spPr>
            <a:xfrm>
              <a:off x="3127782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5.0</a:t>
              </a:r>
            </a:p>
          </p:txBody>
        </p:sp>
        <p:sp>
          <p:nvSpPr>
            <p:cNvPr id="452" name="tx451"/>
            <p:cNvSpPr/>
            <p:nvPr/>
          </p:nvSpPr>
          <p:spPr>
            <a:xfrm>
              <a:off x="3951542" y="5987367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2.5</a:t>
              </a:r>
            </a:p>
          </p:txBody>
        </p:sp>
        <p:sp>
          <p:nvSpPr>
            <p:cNvPr id="453" name="tx452"/>
            <p:cNvSpPr/>
            <p:nvPr/>
          </p:nvSpPr>
          <p:spPr>
            <a:xfrm>
              <a:off x="4793911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454" name="tx453"/>
            <p:cNvSpPr/>
            <p:nvPr/>
          </p:nvSpPr>
          <p:spPr>
            <a:xfrm>
              <a:off x="5617670" y="5987367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5</a:t>
              </a:r>
            </a:p>
          </p:txBody>
        </p:sp>
        <p:sp>
          <p:nvSpPr>
            <p:cNvPr id="455" name="tx454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456" name="tx455"/>
            <p:cNvSpPr/>
            <p:nvPr/>
          </p:nvSpPr>
          <p:spPr>
            <a:xfrm>
              <a:off x="2391921" y="6214480"/>
              <a:ext cx="4141737" cy="9534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Serum uric acid levels || id:ebi-a-GCST90018977' on 'Myocardial infarction || id:finn-b-I9_MI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3-12-18T13:52:37Z</dcterms:modified>
  <cp:category/>
</cp:coreProperties>
</file>